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56" r:id="rId2"/>
  </p:sldIdLst>
  <p:sldSz cx="10972800" cy="5943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276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iuddin, Sayed Golam" userId="5c5f2d06-5da7-4463-8de7-92cf1264e307" providerId="ADAL" clId="{21B79B19-DBD4-41ED-A5FE-D6F52B2AD6D6}"/>
    <pc:docChg chg="custSel modSld">
      <pc:chgData name="Mohiuddin, Sayed Golam" userId="5c5f2d06-5da7-4463-8de7-92cf1264e307" providerId="ADAL" clId="{21B79B19-DBD4-41ED-A5FE-D6F52B2AD6D6}" dt="2023-08-03T22:35:37.322" v="104" actId="20577"/>
      <pc:docMkLst>
        <pc:docMk/>
      </pc:docMkLst>
      <pc:sldChg chg="addSp delSp modSp mod delAnim">
        <pc:chgData name="Mohiuddin, Sayed Golam" userId="5c5f2d06-5da7-4463-8de7-92cf1264e307" providerId="ADAL" clId="{21B79B19-DBD4-41ED-A5FE-D6F52B2AD6D6}" dt="2023-08-03T22:35:37.322" v="104" actId="20577"/>
        <pc:sldMkLst>
          <pc:docMk/>
          <pc:sldMk cId="3094627663" sldId="256"/>
        </pc:sldMkLst>
        <pc:spChg chg="mod">
          <ac:chgData name="Mohiuddin, Sayed Golam" userId="5c5f2d06-5da7-4463-8de7-92cf1264e307" providerId="ADAL" clId="{21B79B19-DBD4-41ED-A5FE-D6F52B2AD6D6}" dt="2023-08-03T22:25:11.344" v="64" actId="1036"/>
          <ac:spMkLst>
            <pc:docMk/>
            <pc:sldMk cId="3094627663" sldId="256"/>
            <ac:spMk id="3" creationId="{11844445-2A08-4619-9BD2-5BA2187F4A90}"/>
          </ac:spMkLst>
        </pc:spChg>
        <pc:spChg chg="mod">
          <ac:chgData name="Mohiuddin, Sayed Golam" userId="5c5f2d06-5da7-4463-8de7-92cf1264e307" providerId="ADAL" clId="{21B79B19-DBD4-41ED-A5FE-D6F52B2AD6D6}" dt="2023-08-03T22:25:11.344" v="64" actId="1036"/>
          <ac:spMkLst>
            <pc:docMk/>
            <pc:sldMk cId="3094627663" sldId="256"/>
            <ac:spMk id="8" creationId="{069C52ED-490B-47D2-8D49-18450E764564}"/>
          </ac:spMkLst>
        </pc:spChg>
        <pc:spChg chg="mod">
          <ac:chgData name="Mohiuddin, Sayed Golam" userId="5c5f2d06-5da7-4463-8de7-92cf1264e307" providerId="ADAL" clId="{21B79B19-DBD4-41ED-A5FE-D6F52B2AD6D6}" dt="2023-08-03T22:25:11.344" v="64" actId="1036"/>
          <ac:spMkLst>
            <pc:docMk/>
            <pc:sldMk cId="3094627663" sldId="256"/>
            <ac:spMk id="9" creationId="{2965E1A5-C5A4-4E60-9AA8-797162D54E5D}"/>
          </ac:spMkLst>
        </pc:spChg>
        <pc:spChg chg="del">
          <ac:chgData name="Mohiuddin, Sayed Golam" userId="5c5f2d06-5da7-4463-8de7-92cf1264e307" providerId="ADAL" clId="{21B79B19-DBD4-41ED-A5FE-D6F52B2AD6D6}" dt="2023-08-03T22:22:33.711" v="1" actId="478"/>
          <ac:spMkLst>
            <pc:docMk/>
            <pc:sldMk cId="3094627663" sldId="256"/>
            <ac:spMk id="10" creationId="{89D1AAB6-0501-4C78-BA23-4573802B0CE5}"/>
          </ac:spMkLst>
        </pc:spChg>
        <pc:spChg chg="del">
          <ac:chgData name="Mohiuddin, Sayed Golam" userId="5c5f2d06-5da7-4463-8de7-92cf1264e307" providerId="ADAL" clId="{21B79B19-DBD4-41ED-A5FE-D6F52B2AD6D6}" dt="2023-08-03T22:22:36.911" v="2" actId="478"/>
          <ac:spMkLst>
            <pc:docMk/>
            <pc:sldMk cId="3094627663" sldId="256"/>
            <ac:spMk id="11" creationId="{2B8653E6-4388-4353-8CA9-6F92F435C710}"/>
          </ac:spMkLst>
        </pc:spChg>
        <pc:spChg chg="mod">
          <ac:chgData name="Mohiuddin, Sayed Golam" userId="5c5f2d06-5da7-4463-8de7-92cf1264e307" providerId="ADAL" clId="{21B79B19-DBD4-41ED-A5FE-D6F52B2AD6D6}" dt="2023-08-03T22:25:11.344" v="64" actId="1036"/>
          <ac:spMkLst>
            <pc:docMk/>
            <pc:sldMk cId="3094627663" sldId="256"/>
            <ac:spMk id="12" creationId="{3D28854F-15C3-436E-8FD8-46310D573967}"/>
          </ac:spMkLst>
        </pc:spChg>
        <pc:spChg chg="del">
          <ac:chgData name="Mohiuddin, Sayed Golam" userId="5c5f2d06-5da7-4463-8de7-92cf1264e307" providerId="ADAL" clId="{21B79B19-DBD4-41ED-A5FE-D6F52B2AD6D6}" dt="2023-08-03T22:22:36.911" v="2" actId="478"/>
          <ac:spMkLst>
            <pc:docMk/>
            <pc:sldMk cId="3094627663" sldId="256"/>
            <ac:spMk id="13" creationId="{B5C0231A-CFA7-4416-ACF2-A01657EE5CDE}"/>
          </ac:spMkLst>
        </pc:spChg>
        <pc:spChg chg="del">
          <ac:chgData name="Mohiuddin, Sayed Golam" userId="5c5f2d06-5da7-4463-8de7-92cf1264e307" providerId="ADAL" clId="{21B79B19-DBD4-41ED-A5FE-D6F52B2AD6D6}" dt="2023-08-03T22:22:36.911" v="2" actId="478"/>
          <ac:spMkLst>
            <pc:docMk/>
            <pc:sldMk cId="3094627663" sldId="256"/>
            <ac:spMk id="14" creationId="{5984CD19-EB02-47E6-ACDB-690FF7F1268A}"/>
          </ac:spMkLst>
        </pc:spChg>
        <pc:spChg chg="add mod">
          <ac:chgData name="Mohiuddin, Sayed Golam" userId="5c5f2d06-5da7-4463-8de7-92cf1264e307" providerId="ADAL" clId="{21B79B19-DBD4-41ED-A5FE-D6F52B2AD6D6}" dt="2023-08-03T22:35:37.322" v="104" actId="20577"/>
          <ac:spMkLst>
            <pc:docMk/>
            <pc:sldMk cId="3094627663" sldId="256"/>
            <ac:spMk id="15" creationId="{21DF43A1-083B-44CD-AA52-03DD8E563374}"/>
          </ac:spMkLst>
        </pc:spChg>
        <pc:picChg chg="del">
          <ac:chgData name="Mohiuddin, Sayed Golam" userId="5c5f2d06-5da7-4463-8de7-92cf1264e307" providerId="ADAL" clId="{21B79B19-DBD4-41ED-A5FE-D6F52B2AD6D6}" dt="2023-08-03T22:22:30.888" v="0" actId="478"/>
          <ac:picMkLst>
            <pc:docMk/>
            <pc:sldMk cId="3094627663" sldId="256"/>
            <ac:picMk id="2" creationId="{D5A1A32A-9F3D-4452-A5E3-A4E849071F3D}"/>
          </ac:picMkLst>
        </pc:picChg>
        <pc:picChg chg="mod">
          <ac:chgData name="Mohiuddin, Sayed Golam" userId="5c5f2d06-5da7-4463-8de7-92cf1264e307" providerId="ADAL" clId="{21B79B19-DBD4-41ED-A5FE-D6F52B2AD6D6}" dt="2023-08-03T22:25:32.866" v="66" actId="1076"/>
          <ac:picMkLst>
            <pc:docMk/>
            <pc:sldMk cId="3094627663" sldId="256"/>
            <ac:picMk id="4" creationId="{DD494BB7-BF3B-4E5D-9F55-1F5A42CE5C9A}"/>
          </ac:picMkLst>
        </pc:picChg>
        <pc:picChg chg="mod">
          <ac:chgData name="Mohiuddin, Sayed Golam" userId="5c5f2d06-5da7-4463-8de7-92cf1264e307" providerId="ADAL" clId="{21B79B19-DBD4-41ED-A5FE-D6F52B2AD6D6}" dt="2023-08-03T22:25:11.344" v="64" actId="1036"/>
          <ac:picMkLst>
            <pc:docMk/>
            <pc:sldMk cId="3094627663" sldId="256"/>
            <ac:picMk id="5" creationId="{8476CE1E-7056-4238-A1C7-802F48FD0F53}"/>
          </ac:picMkLst>
        </pc:picChg>
        <pc:picChg chg="del">
          <ac:chgData name="Mohiuddin, Sayed Golam" userId="5c5f2d06-5da7-4463-8de7-92cf1264e307" providerId="ADAL" clId="{21B79B19-DBD4-41ED-A5FE-D6F52B2AD6D6}" dt="2023-08-03T22:22:30.888" v="0" actId="478"/>
          <ac:picMkLst>
            <pc:docMk/>
            <pc:sldMk cId="3094627663" sldId="256"/>
            <ac:picMk id="7" creationId="{51BEC443-E9EC-4B0E-B067-629540807CB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57649F-66FE-4D30-9952-DF376910F263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81025" y="1143000"/>
            <a:ext cx="5695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783FEC-2984-481A-A8D1-21F95A932C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589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581025" y="1143000"/>
            <a:ext cx="56959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783FEC-2984-481A-A8D1-21F95A932C4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422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972715"/>
            <a:ext cx="8229600" cy="2069253"/>
          </a:xfrm>
        </p:spPr>
        <p:txBody>
          <a:bodyPr anchor="b"/>
          <a:lstStyle>
            <a:lvl1pPr algn="ctr">
              <a:defRPr sz="5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121766"/>
            <a:ext cx="8229600" cy="1434994"/>
          </a:xfrm>
        </p:spPr>
        <p:txBody>
          <a:bodyPr/>
          <a:lstStyle>
            <a:lvl1pPr marL="0" indent="0" algn="ctr">
              <a:buNone/>
              <a:defRPr sz="2080"/>
            </a:lvl1pPr>
            <a:lvl2pPr marL="396255" indent="0" algn="ctr">
              <a:buNone/>
              <a:defRPr sz="1733"/>
            </a:lvl2pPr>
            <a:lvl3pPr marL="792510" indent="0" algn="ctr">
              <a:buNone/>
              <a:defRPr sz="1560"/>
            </a:lvl3pPr>
            <a:lvl4pPr marL="1188766" indent="0" algn="ctr">
              <a:buNone/>
              <a:defRPr sz="1387"/>
            </a:lvl4pPr>
            <a:lvl5pPr marL="1585021" indent="0" algn="ctr">
              <a:buNone/>
              <a:defRPr sz="1387"/>
            </a:lvl5pPr>
            <a:lvl6pPr marL="1981276" indent="0" algn="ctr">
              <a:buNone/>
              <a:defRPr sz="1387"/>
            </a:lvl6pPr>
            <a:lvl7pPr marL="2377531" indent="0" algn="ctr">
              <a:buNone/>
              <a:defRPr sz="1387"/>
            </a:lvl7pPr>
            <a:lvl8pPr marL="2773787" indent="0" algn="ctr">
              <a:buNone/>
              <a:defRPr sz="1387"/>
            </a:lvl8pPr>
            <a:lvl9pPr marL="3170042" indent="0" algn="ctr">
              <a:buNone/>
              <a:defRPr sz="138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082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27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0" y="316442"/>
            <a:ext cx="2366010" cy="503692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0" y="316442"/>
            <a:ext cx="6960870" cy="503692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1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988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5" y="1481773"/>
            <a:ext cx="9464040" cy="2472372"/>
          </a:xfrm>
        </p:spPr>
        <p:txBody>
          <a:bodyPr anchor="b"/>
          <a:lstStyle>
            <a:lvl1pPr>
              <a:defRPr sz="5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5" y="3977535"/>
            <a:ext cx="9464040" cy="1300162"/>
          </a:xfrm>
        </p:spPr>
        <p:txBody>
          <a:bodyPr/>
          <a:lstStyle>
            <a:lvl1pPr marL="0" indent="0">
              <a:buNone/>
              <a:defRPr sz="2080">
                <a:solidFill>
                  <a:schemeClr val="tx1">
                    <a:tint val="75000"/>
                  </a:schemeClr>
                </a:solidFill>
              </a:defRPr>
            </a:lvl1pPr>
            <a:lvl2pPr marL="396255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2pPr>
            <a:lvl3pPr marL="79251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3pPr>
            <a:lvl4pPr marL="1188766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4pPr>
            <a:lvl5pPr marL="1585021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5pPr>
            <a:lvl6pPr marL="1981276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6pPr>
            <a:lvl7pPr marL="2377531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7pPr>
            <a:lvl8pPr marL="2773787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8pPr>
            <a:lvl9pPr marL="3170042" indent="0">
              <a:buNone/>
              <a:defRPr sz="138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715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1582208"/>
            <a:ext cx="4663440" cy="3771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1582208"/>
            <a:ext cx="4663440" cy="37711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974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316442"/>
            <a:ext cx="9464040" cy="11488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1457008"/>
            <a:ext cx="4642008" cy="714057"/>
          </a:xfrm>
        </p:spPr>
        <p:txBody>
          <a:bodyPr anchor="b"/>
          <a:lstStyle>
            <a:lvl1pPr marL="0" indent="0">
              <a:buNone/>
              <a:defRPr sz="2080" b="1"/>
            </a:lvl1pPr>
            <a:lvl2pPr marL="396255" indent="0">
              <a:buNone/>
              <a:defRPr sz="1733" b="1"/>
            </a:lvl2pPr>
            <a:lvl3pPr marL="792510" indent="0">
              <a:buNone/>
              <a:defRPr sz="1560" b="1"/>
            </a:lvl3pPr>
            <a:lvl4pPr marL="1188766" indent="0">
              <a:buNone/>
              <a:defRPr sz="1387" b="1"/>
            </a:lvl4pPr>
            <a:lvl5pPr marL="1585021" indent="0">
              <a:buNone/>
              <a:defRPr sz="1387" b="1"/>
            </a:lvl5pPr>
            <a:lvl6pPr marL="1981276" indent="0">
              <a:buNone/>
              <a:defRPr sz="1387" b="1"/>
            </a:lvl6pPr>
            <a:lvl7pPr marL="2377531" indent="0">
              <a:buNone/>
              <a:defRPr sz="1387" b="1"/>
            </a:lvl7pPr>
            <a:lvl8pPr marL="2773787" indent="0">
              <a:buNone/>
              <a:defRPr sz="1387" b="1"/>
            </a:lvl8pPr>
            <a:lvl9pPr marL="3170042" indent="0">
              <a:buNone/>
              <a:defRPr sz="13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2171065"/>
            <a:ext cx="4642008" cy="3193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0" y="1457008"/>
            <a:ext cx="4664869" cy="714057"/>
          </a:xfrm>
        </p:spPr>
        <p:txBody>
          <a:bodyPr anchor="b"/>
          <a:lstStyle>
            <a:lvl1pPr marL="0" indent="0">
              <a:buNone/>
              <a:defRPr sz="2080" b="1"/>
            </a:lvl1pPr>
            <a:lvl2pPr marL="396255" indent="0">
              <a:buNone/>
              <a:defRPr sz="1733" b="1"/>
            </a:lvl2pPr>
            <a:lvl3pPr marL="792510" indent="0">
              <a:buNone/>
              <a:defRPr sz="1560" b="1"/>
            </a:lvl3pPr>
            <a:lvl4pPr marL="1188766" indent="0">
              <a:buNone/>
              <a:defRPr sz="1387" b="1"/>
            </a:lvl4pPr>
            <a:lvl5pPr marL="1585021" indent="0">
              <a:buNone/>
              <a:defRPr sz="1387" b="1"/>
            </a:lvl5pPr>
            <a:lvl6pPr marL="1981276" indent="0">
              <a:buNone/>
              <a:defRPr sz="1387" b="1"/>
            </a:lvl6pPr>
            <a:lvl7pPr marL="2377531" indent="0">
              <a:buNone/>
              <a:defRPr sz="1387" b="1"/>
            </a:lvl7pPr>
            <a:lvl8pPr marL="2773787" indent="0">
              <a:buNone/>
              <a:defRPr sz="1387" b="1"/>
            </a:lvl8pPr>
            <a:lvl9pPr marL="3170042" indent="0">
              <a:buNone/>
              <a:defRPr sz="138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0" y="2171065"/>
            <a:ext cx="4664869" cy="3193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064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17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294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96240"/>
            <a:ext cx="3539013" cy="1386840"/>
          </a:xfrm>
        </p:spPr>
        <p:txBody>
          <a:bodyPr anchor="b"/>
          <a:lstStyle>
            <a:lvl1pPr>
              <a:defRPr sz="27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855769"/>
            <a:ext cx="5554980" cy="4223808"/>
          </a:xfrm>
        </p:spPr>
        <p:txBody>
          <a:bodyPr/>
          <a:lstStyle>
            <a:lvl1pPr>
              <a:defRPr sz="2773"/>
            </a:lvl1pPr>
            <a:lvl2pPr>
              <a:defRPr sz="2427"/>
            </a:lvl2pPr>
            <a:lvl3pPr>
              <a:defRPr sz="208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783080"/>
            <a:ext cx="3539013" cy="3303376"/>
          </a:xfrm>
        </p:spPr>
        <p:txBody>
          <a:bodyPr/>
          <a:lstStyle>
            <a:lvl1pPr marL="0" indent="0">
              <a:buNone/>
              <a:defRPr sz="1387"/>
            </a:lvl1pPr>
            <a:lvl2pPr marL="396255" indent="0">
              <a:buNone/>
              <a:defRPr sz="1213"/>
            </a:lvl2pPr>
            <a:lvl3pPr marL="792510" indent="0">
              <a:buNone/>
              <a:defRPr sz="1040"/>
            </a:lvl3pPr>
            <a:lvl4pPr marL="1188766" indent="0">
              <a:buNone/>
              <a:defRPr sz="867"/>
            </a:lvl4pPr>
            <a:lvl5pPr marL="1585021" indent="0">
              <a:buNone/>
              <a:defRPr sz="867"/>
            </a:lvl5pPr>
            <a:lvl6pPr marL="1981276" indent="0">
              <a:buNone/>
              <a:defRPr sz="867"/>
            </a:lvl6pPr>
            <a:lvl7pPr marL="2377531" indent="0">
              <a:buNone/>
              <a:defRPr sz="867"/>
            </a:lvl7pPr>
            <a:lvl8pPr marL="2773787" indent="0">
              <a:buNone/>
              <a:defRPr sz="867"/>
            </a:lvl8pPr>
            <a:lvl9pPr marL="3170042" indent="0">
              <a:buNone/>
              <a:defRPr sz="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747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96240"/>
            <a:ext cx="3539013" cy="1386840"/>
          </a:xfrm>
        </p:spPr>
        <p:txBody>
          <a:bodyPr anchor="b"/>
          <a:lstStyle>
            <a:lvl1pPr>
              <a:defRPr sz="277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855769"/>
            <a:ext cx="5554980" cy="4223808"/>
          </a:xfrm>
        </p:spPr>
        <p:txBody>
          <a:bodyPr anchor="t"/>
          <a:lstStyle>
            <a:lvl1pPr marL="0" indent="0">
              <a:buNone/>
              <a:defRPr sz="2773"/>
            </a:lvl1pPr>
            <a:lvl2pPr marL="396255" indent="0">
              <a:buNone/>
              <a:defRPr sz="2427"/>
            </a:lvl2pPr>
            <a:lvl3pPr marL="792510" indent="0">
              <a:buNone/>
              <a:defRPr sz="2080"/>
            </a:lvl3pPr>
            <a:lvl4pPr marL="1188766" indent="0">
              <a:buNone/>
              <a:defRPr sz="1733"/>
            </a:lvl4pPr>
            <a:lvl5pPr marL="1585021" indent="0">
              <a:buNone/>
              <a:defRPr sz="1733"/>
            </a:lvl5pPr>
            <a:lvl6pPr marL="1981276" indent="0">
              <a:buNone/>
              <a:defRPr sz="1733"/>
            </a:lvl6pPr>
            <a:lvl7pPr marL="2377531" indent="0">
              <a:buNone/>
              <a:defRPr sz="1733"/>
            </a:lvl7pPr>
            <a:lvl8pPr marL="2773787" indent="0">
              <a:buNone/>
              <a:defRPr sz="1733"/>
            </a:lvl8pPr>
            <a:lvl9pPr marL="3170042" indent="0">
              <a:buNone/>
              <a:defRPr sz="17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783080"/>
            <a:ext cx="3539013" cy="3303376"/>
          </a:xfrm>
        </p:spPr>
        <p:txBody>
          <a:bodyPr/>
          <a:lstStyle>
            <a:lvl1pPr marL="0" indent="0">
              <a:buNone/>
              <a:defRPr sz="1387"/>
            </a:lvl1pPr>
            <a:lvl2pPr marL="396255" indent="0">
              <a:buNone/>
              <a:defRPr sz="1213"/>
            </a:lvl2pPr>
            <a:lvl3pPr marL="792510" indent="0">
              <a:buNone/>
              <a:defRPr sz="1040"/>
            </a:lvl3pPr>
            <a:lvl4pPr marL="1188766" indent="0">
              <a:buNone/>
              <a:defRPr sz="867"/>
            </a:lvl4pPr>
            <a:lvl5pPr marL="1585021" indent="0">
              <a:buNone/>
              <a:defRPr sz="867"/>
            </a:lvl5pPr>
            <a:lvl6pPr marL="1981276" indent="0">
              <a:buNone/>
              <a:defRPr sz="867"/>
            </a:lvl6pPr>
            <a:lvl7pPr marL="2377531" indent="0">
              <a:buNone/>
              <a:defRPr sz="867"/>
            </a:lvl7pPr>
            <a:lvl8pPr marL="2773787" indent="0">
              <a:buNone/>
              <a:defRPr sz="867"/>
            </a:lvl8pPr>
            <a:lvl9pPr marL="3170042" indent="0">
              <a:buNone/>
              <a:defRPr sz="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39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316442"/>
            <a:ext cx="9464040" cy="1148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1582208"/>
            <a:ext cx="9464040" cy="37711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5508837"/>
            <a:ext cx="246888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46A6D-1B67-4CE3-B2DA-6D698CD40E06}" type="datetimeFigureOut">
              <a:rPr lang="en-US" smtClean="0"/>
              <a:t>10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5508837"/>
            <a:ext cx="370332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5508837"/>
            <a:ext cx="2468880" cy="3164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74CA6-13F0-4605-9865-9935FFCDC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680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92510" rtl="0" eaLnBrk="1" latinLnBrk="0" hangingPunct="1">
        <a:lnSpc>
          <a:spcPct val="90000"/>
        </a:lnSpc>
        <a:spcBef>
          <a:spcPct val="0"/>
        </a:spcBef>
        <a:buNone/>
        <a:defRPr sz="38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8128" indent="-198128" algn="l" defTabSz="792510" rtl="0" eaLnBrk="1" latinLnBrk="0" hangingPunct="1">
        <a:lnSpc>
          <a:spcPct val="90000"/>
        </a:lnSpc>
        <a:spcBef>
          <a:spcPts val="867"/>
        </a:spcBef>
        <a:buFont typeface="Arial" panose="020B0604020202020204" pitchFamily="34" charset="0"/>
        <a:buChar char="•"/>
        <a:defRPr sz="2427" kern="1200">
          <a:solidFill>
            <a:schemeClr val="tx1"/>
          </a:solidFill>
          <a:latin typeface="+mn-lt"/>
          <a:ea typeface="+mn-ea"/>
          <a:cs typeface="+mn-cs"/>
        </a:defRPr>
      </a:lvl1pPr>
      <a:lvl2pPr marL="594383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80" kern="1200">
          <a:solidFill>
            <a:schemeClr val="tx1"/>
          </a:solidFill>
          <a:latin typeface="+mn-lt"/>
          <a:ea typeface="+mn-ea"/>
          <a:cs typeface="+mn-cs"/>
        </a:defRPr>
      </a:lvl2pPr>
      <a:lvl3pPr marL="990638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3pPr>
      <a:lvl4pPr marL="1386893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4pPr>
      <a:lvl5pPr marL="1783149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5pPr>
      <a:lvl6pPr marL="2179404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6pPr>
      <a:lvl7pPr marL="2575659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7pPr>
      <a:lvl8pPr marL="2971914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8pPr>
      <a:lvl9pPr marL="3368170" indent="-198128" algn="l" defTabSz="792510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1pPr>
      <a:lvl2pPr marL="396255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2pPr>
      <a:lvl3pPr marL="792510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66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4pPr>
      <a:lvl5pPr marL="1585021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5pPr>
      <a:lvl6pPr marL="1981276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6pPr>
      <a:lvl7pPr marL="2377531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7pPr>
      <a:lvl8pPr marL="2773787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8pPr>
      <a:lvl9pPr marL="3170042" algn="l" defTabSz="792510" rtl="0" eaLnBrk="1" latinLnBrk="0" hangingPunct="1">
        <a:defRPr sz="1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G1655_untracked_1">
            <a:hlinkClick r:id="" action="ppaction://media"/>
            <a:extLst>
              <a:ext uri="{FF2B5EF4-FFF2-40B4-BE49-F238E27FC236}">
                <a16:creationId xmlns:a16="http://schemas.microsoft.com/office/drawing/2014/main" id="{DD494BB7-BF3B-4E5D-9F55-1F5A42CE5C9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31949" y="649764"/>
            <a:ext cx="4304899" cy="3397362"/>
          </a:xfrm>
          <a:prstGeom prst="rect">
            <a:avLst/>
          </a:prstGeom>
        </p:spPr>
      </p:pic>
      <p:pic>
        <p:nvPicPr>
          <p:cNvPr id="5" name="MG1655_tracked_1">
            <a:hlinkClick r:id="" action="ppaction://media"/>
            <a:extLst>
              <a:ext uri="{FF2B5EF4-FFF2-40B4-BE49-F238E27FC236}">
                <a16:creationId xmlns:a16="http://schemas.microsoft.com/office/drawing/2014/main" id="{8476CE1E-7056-4238-A1C7-802F48FD0F5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1507" t="2591" r="1143" b="2803"/>
          <a:stretch/>
        </p:blipFill>
        <p:spPr>
          <a:xfrm>
            <a:off x="5926339" y="551102"/>
            <a:ext cx="4536490" cy="35946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9C52ED-490B-47D2-8D49-18450E764564}"/>
              </a:ext>
            </a:extLst>
          </p:cNvPr>
          <p:cNvSpPr txBox="1"/>
          <p:nvPr/>
        </p:nvSpPr>
        <p:spPr>
          <a:xfrm>
            <a:off x="1410408" y="67298"/>
            <a:ext cx="3057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E. coli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G1655 (untracked)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65E1A5-C5A4-4E60-9AA8-797162D54E5D}"/>
              </a:ext>
            </a:extLst>
          </p:cNvPr>
          <p:cNvSpPr txBox="1"/>
          <p:nvPr/>
        </p:nvSpPr>
        <p:spPr>
          <a:xfrm>
            <a:off x="6974439" y="88284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E. coli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MG1655 (tracked)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844445-2A08-4619-9BD2-5BA2187F4A90}"/>
              </a:ext>
            </a:extLst>
          </p:cNvPr>
          <p:cNvSpPr txBox="1"/>
          <p:nvPr/>
        </p:nvSpPr>
        <p:spPr>
          <a:xfrm>
            <a:off x="23052" y="21857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28854F-15C3-436E-8FD8-46310D573967}"/>
              </a:ext>
            </a:extLst>
          </p:cNvPr>
          <p:cNvSpPr txBox="1"/>
          <p:nvPr/>
        </p:nvSpPr>
        <p:spPr>
          <a:xfrm>
            <a:off x="5498819" y="21133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DF43A1-083B-44CD-AA52-03DD8E563374}"/>
              </a:ext>
            </a:extLst>
          </p:cNvPr>
          <p:cNvSpPr txBox="1"/>
          <p:nvPr/>
        </p:nvSpPr>
        <p:spPr>
          <a:xfrm>
            <a:off x="496200" y="4344350"/>
            <a:ext cx="1000523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ovie S2. Representative movies for bacterial strains. (a-b)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Untracked and tracke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Escherichia col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MG1655 cells, respectively. Single-cell tracking in panel “b”, highlighted in red circles, is performed using a MATLAB code. The tracked video (panel b) is ~8 times slower than its original version (panel a ).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46276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772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56956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</TotalTime>
  <Words>78</Words>
  <Application>Microsoft Office PowerPoint</Application>
  <PresentationFormat>Custom</PresentationFormat>
  <Paragraphs>6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iuddin, Sayed Golam</dc:creator>
  <cp:lastModifiedBy>Sayed Golam Mohiuddin</cp:lastModifiedBy>
  <cp:revision>24</cp:revision>
  <dcterms:created xsi:type="dcterms:W3CDTF">2023-07-18T23:55:47Z</dcterms:created>
  <dcterms:modified xsi:type="dcterms:W3CDTF">2024-10-17T21:02:03Z</dcterms:modified>
</cp:coreProperties>
</file>